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167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25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614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58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418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909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184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277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95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439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731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110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0A90-A9BF-48C8-B9FB-2758E2EE8AA8}" type="datetimeFigureOut">
              <a:rPr lang="en-US" smtClean="0"/>
              <a:t>12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248A8-8310-473B-971F-055649E5F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414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8753" y="360515"/>
            <a:ext cx="4132386" cy="3921338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58261" y="4503456"/>
            <a:ext cx="877472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of th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rciano-Granadin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 employed in the GWAS as assessed by principal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analysis (PCA)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d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oat SNP50 </a:t>
            </a:r>
            <a:r>
              <a:rPr lang="en-GB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adChip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s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1 and PC2 indicate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rincipal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s 1 and 2, respectively. Values in parentheses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lect the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variance in the data explained by each principal component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4016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Dailu Guan</cp:lastModifiedBy>
  <cp:revision>10</cp:revision>
  <dcterms:created xsi:type="dcterms:W3CDTF">2019-08-02T16:11:47Z</dcterms:created>
  <dcterms:modified xsi:type="dcterms:W3CDTF">2019-12-27T10:37:09Z</dcterms:modified>
</cp:coreProperties>
</file>